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00" d="100"/>
          <a:sy n="100" d="100"/>
        </p:scale>
        <p:origin x="235" y="-379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142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937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275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124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31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168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09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186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597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47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103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36EBC-B526-4596-AA26-5E5E5E1A86CB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B293B3-1358-4A96-9E2C-0B6715ADC7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163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845820" y="2898416"/>
            <a:ext cx="320040" cy="3691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45820" y="5234394"/>
            <a:ext cx="320040" cy="3691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8" name="Rectangle 7"/>
          <p:cNvSpPr/>
          <p:nvPr/>
        </p:nvSpPr>
        <p:spPr>
          <a:xfrm>
            <a:off x="795867" y="3331931"/>
            <a:ext cx="54864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AGCGGAAAGCCTGGTACAACAAATATGGGGCGCGTATATGGAAAAGGGTATTTATTTCATTTATATAAAATAAAAACGACATATTTATATGTCGTTTTTATCAGGCTGTGGAGAAAGTCTTCTCCACAGCCTATTTTTGTGTCTGAACCTCTTTTTATGTGTCAACACTGATAAAAAAGAGGAAAAGGAGAGATTTCTTATGATGGGTGCTTTAAAAAATCATCGTGATGAGCGCGTATCTGTTTCTGTAGAAGAATTGGTTCCACAATATCATTTCCTTCGTGCGATTGAAGCGACAATTAGTCCGGGAGCATGCGACGGGGGATCCACTAGTTCTAGAGCGGCCGCCACCGCGGTGGAGCTC</a:t>
            </a:r>
            <a:r>
              <a:rPr lang="en-US" sz="12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ATACCACAATAAATAATGCGTTTATTGTGGTATAA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CAGCTGCTCGAGAACTAATAACCCCCCTTACAATCTAGTTTTTTGTTCTAAATCGTAAGGGGTTTTATTAGTTATATTTCTTTTTTAGTTCATAATATGAATGAATATATTCTTTTTTTAATTTATAATAGGAATATATCGTACTATAA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95867" y="8389616"/>
            <a:ext cx="54864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3 Fig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Confirmation of </a:t>
            </a:r>
            <a:r>
              <a:rPr lang="en-US" sz="1200" b="1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xP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L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tes location within </a:t>
            </a:r>
            <a:r>
              <a:rPr lang="en-US" sz="1200" b="1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xA</a:t>
            </a:r>
            <a:r>
              <a:rPr lang="en-US" sz="12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ergenic regions in strains with double and triple </a:t>
            </a:r>
            <a:r>
              <a:rPr lang="en-US" sz="1200" b="1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xA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s. </a:t>
            </a:r>
          </a:p>
          <a:p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ers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ALAF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ALAR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re used for sequencing of PCR fragments amplified with the same primers and demonstrated on Fig. 3D. A -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SL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site was identified in the sequence of top PCR fragment (indicated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bold blue). B - The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xP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site was identified in the sequence of the bottom PCR fragment (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icated in bold red)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600565" y="2338468"/>
            <a:ext cx="1320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3 Fig. </a:t>
            </a:r>
          </a:p>
        </p:txBody>
      </p:sp>
      <p:sp>
        <p:nvSpPr>
          <p:cNvPr id="10" name="Rectangle 9"/>
          <p:cNvSpPr/>
          <p:nvPr/>
        </p:nvSpPr>
        <p:spPr>
          <a:xfrm>
            <a:off x="795867" y="5615923"/>
            <a:ext cx="5486400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GTATATAGTTTTTTTATTTGGCGGTTTCTTATTTACTTGGAAATATATTGACCGCTGATATAGTAACAAAATTGAAACATAACGTTGATATTAGGGCTGAAGGAAGCGGAAAGCCTGGTACAAGAAATATGGGGCGCGTATATGGAAAAGGGTATTTATTTCATTTATATAAAATAAAAACGACATATTTATATGTCGTTTTTATCAGGCTGTGGAGAAAGTCTTCTCCACAGCCTATTTTTGTGTCTGAACCTCTTTTTATGTGTCAACACTGATAAAAAAGAGGAAAAGGAGAGATTTCTTATGATGGGTGCTTTAAAAAATCATCGTGATGAGCGTGTATCTGTTTCTGTAGAAGAATTGGTTCCACAATATCATTTCCTTCGTGCGATTGAAGCGACAATTAGTTTTGAGTTTATTGAGGAGAAGCGACGGGGGATCCACTAGTTCTAGAGCGGCCGCCACCGCGGTGGAGCTC</a:t>
            </a:r>
            <a:r>
              <a:rPr lang="en-US" sz="12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AACTTCGTATAATGTATGCTATACGAAGTTAT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CAGCTGCTCGAGAACTAATAACCCCCCTTACAATCTAGTTTTTTGTTCTAAATCGTAAGGGGTTTTATTAGTTATATTTCTTTTTTAGTTCATAATATGAATGAATATATTCTTTTTTTAATTTATAATAGGAATATATCGTACTATAAATTAAATGATCAAAGAACAAATTTATCTGTTCAATTA</a:t>
            </a:r>
            <a:endParaRPr lang="en-US" sz="1200" b="1" dirty="0">
              <a:solidFill>
                <a:srgbClr val="00B05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805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5</TotalTime>
  <Words>92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Company>NIH\NIAI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merantsev, Andrei (NIH/NIAID) [E]</dc:creator>
  <cp:lastModifiedBy>Pomerantsev, Andrei (NIH/NIAID) [E]</cp:lastModifiedBy>
  <cp:revision>19</cp:revision>
  <cp:lastPrinted>2016-12-15T14:47:07Z</cp:lastPrinted>
  <dcterms:created xsi:type="dcterms:W3CDTF">2016-12-12T17:53:34Z</dcterms:created>
  <dcterms:modified xsi:type="dcterms:W3CDTF">2017-05-11T15:05:06Z</dcterms:modified>
</cp:coreProperties>
</file>